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8" r:id="rId2"/>
  </p:sldIdLst>
  <p:sldSz cx="9144000" cy="6858000" type="screen4x3"/>
  <p:notesSz cx="6797675" cy="992822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342" y="6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C4A77B-6283-4730-BC35-91550FBFC96C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AC3CCF-6B98-4EF6-BB44-125CA4232D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0861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FC37AB-B8FC-470D-B252-BE2130B17F5D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B9785C-D423-45BB-A6D4-2A9574A32B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7148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5C8761-A422-401C-934F-DBB434D69F50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496F16-8245-4CC6-B49A-CA3E3A46380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71CE55-6C7D-4145-8460-9AD6D3679E1A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36B242-A357-4C6A-8CF1-B3F5C74775C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93D18F-C672-499C-8F87-19232F6E6709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AC726E-0186-4A77-97B7-F45801C04DE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80F586-8630-49BB-8DF2-F3F42D03327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D1C440-DEBD-496C-BFDD-5CC6DA0A71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8D108B-CC42-4EC1-97B6-602A037E04CE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B7E995-D04A-458D-A2B8-EB0DD53F0C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17BCEF-2346-4706-A4EB-A6E714A2D31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F4B1D9-8E9A-4794-8D91-0428B304400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C283F5-7672-4CA6-B4C5-02C42780DFD5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6EE5E1-2B6E-4C7F-8984-CAA8CECAAF4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1667B2-222A-4613-B5FD-AFF51622079D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345384-5FD2-4804-B082-19F88AF9988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8AFD0A-1B8D-4B43-B27D-834DEA511307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CF406C-30C0-4708-A53A-6DA1084107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16F876-A80F-4237-96C7-029811984924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B0E952-FD0B-4713-8FC1-C76196ECD0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3996F7-9BFF-4EF4-97A2-72E097AE9F9C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FBF5A2-3AF0-401F-AAAE-86AFA84729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DE5559E7-C590-4B48-8F91-8FF7791530FB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8AC322C4-652A-466C-B9B6-4BC3DA09997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123" charset="-128"/>
          <a:cs typeface="ＭＳ Ｐゴシック" pitchFamily="-123" charset="-128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3200" kern="1200">
          <a:solidFill>
            <a:schemeClr val="tx1"/>
          </a:solidFill>
          <a:latin typeface="+mn-lt"/>
          <a:ea typeface="ＭＳ Ｐゴシック" pitchFamily="-123" charset="-128"/>
          <a:cs typeface="ＭＳ Ｐゴシック" pitchFamily="-123" charset="-128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8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24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»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Rectangle 1"/>
          <p:cNvSpPr>
            <a:spLocks noChangeArrowheads="1"/>
          </p:cNvSpPr>
          <p:nvPr/>
        </p:nvSpPr>
        <p:spPr bwMode="auto">
          <a:xfrm>
            <a:off x="-36512" y="9522"/>
            <a:ext cx="165732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GB" altLang="zh-HK" dirty="0"/>
              <a:t>Figure S</a:t>
            </a:r>
            <a:r>
              <a:rPr lang="en-US" altLang="zh-TW" dirty="0"/>
              <a:t>2</a:t>
            </a:r>
            <a:endParaRPr lang="en-GB" altLang="zh-HK" dirty="0"/>
          </a:p>
        </p:txBody>
      </p:sp>
      <p:pic>
        <p:nvPicPr>
          <p:cNvPr id="14338" name="Picture 2"/>
          <p:cNvPicPr>
            <a:picLocks noChangeAspect="1"/>
          </p:cNvPicPr>
          <p:nvPr/>
        </p:nvPicPr>
        <p:blipFill>
          <a:blip r:embed="rId2"/>
          <a:srcRect t="40141" b="32207"/>
          <a:stretch>
            <a:fillRect/>
          </a:stretch>
        </p:blipFill>
        <p:spPr bwMode="auto">
          <a:xfrm rot="3154083">
            <a:off x="6397403" y="2254797"/>
            <a:ext cx="2859762" cy="856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339" name="TextBox 3"/>
          <p:cNvSpPr txBox="1">
            <a:spLocks noChangeArrowheads="1"/>
          </p:cNvSpPr>
          <p:nvPr/>
        </p:nvSpPr>
        <p:spPr bwMode="auto">
          <a:xfrm>
            <a:off x="6747524" y="652206"/>
            <a:ext cx="1528762" cy="830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600" dirty="0">
                <a:latin typeface="Calibri" pitchFamily="-123" charset="0"/>
                <a:ea typeface="新細明體" pitchFamily="-123" charset="-120"/>
                <a:cs typeface="新細明體" pitchFamily="-123" charset="-120"/>
              </a:rPr>
              <a:t>Cyclin D1</a:t>
            </a:r>
          </a:p>
          <a:p>
            <a:r>
              <a:rPr lang="en-US" sz="1600" dirty="0">
                <a:latin typeface="Calibri" pitchFamily="-123" charset="0"/>
                <a:ea typeface="新細明體" pitchFamily="-123" charset="-120"/>
                <a:cs typeface="新細明體" pitchFamily="-123" charset="-120"/>
              </a:rPr>
              <a:t>-78.21 kcal/mol.</a:t>
            </a:r>
          </a:p>
          <a:p>
            <a:endParaRPr lang="zh-HK" sz="1600" dirty="0">
              <a:latin typeface="Calibri" pitchFamily="-123" charset="0"/>
              <a:ea typeface="新細明體" pitchFamily="-123" charset="-120"/>
              <a:cs typeface="新細明體" pitchFamily="-123" charset="-120"/>
            </a:endParaRPr>
          </a:p>
        </p:txBody>
      </p:sp>
      <p:pic>
        <p:nvPicPr>
          <p:cNvPr id="14340" name="Picture 4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 rot="7243310">
            <a:off x="4567375" y="1195147"/>
            <a:ext cx="2585505" cy="28005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341" name="TextBox 5"/>
          <p:cNvSpPr txBox="1">
            <a:spLocks noChangeArrowheads="1"/>
          </p:cNvSpPr>
          <p:nvPr/>
        </p:nvSpPr>
        <p:spPr bwMode="auto">
          <a:xfrm>
            <a:off x="4760129" y="652206"/>
            <a:ext cx="1527175" cy="585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600" dirty="0">
                <a:latin typeface="Calibri" pitchFamily="-123" charset="0"/>
                <a:ea typeface="新細明體" pitchFamily="-123" charset="-120"/>
                <a:cs typeface="新細明體" pitchFamily="-123" charset="-120"/>
              </a:rPr>
              <a:t>MYC</a:t>
            </a:r>
          </a:p>
          <a:p>
            <a:r>
              <a:rPr lang="en-US" sz="1600" dirty="0">
                <a:latin typeface="Calibri" pitchFamily="-123" charset="0"/>
                <a:ea typeface="新細明體" pitchFamily="-123" charset="-120"/>
                <a:cs typeface="新細明體" pitchFamily="-123" charset="-120"/>
              </a:rPr>
              <a:t>-82.50 kcal/mol.</a:t>
            </a:r>
            <a:endParaRPr lang="zh-HK" sz="1600" dirty="0">
              <a:latin typeface="Calibri" pitchFamily="-123" charset="0"/>
              <a:ea typeface="新細明體" pitchFamily="-123" charset="-120"/>
              <a:cs typeface="新細明體" pitchFamily="-123" charset="-12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4448067">
            <a:off x="855618" y="1381465"/>
            <a:ext cx="1464435" cy="1464435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833276" y="691053"/>
            <a:ext cx="17722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HK" sz="1400" dirty="0"/>
              <a:t>β</a:t>
            </a:r>
            <a:r>
              <a:rPr lang="en-US" altLang="zh-HK" sz="1400" dirty="0"/>
              <a:t>-actin</a:t>
            </a:r>
          </a:p>
          <a:p>
            <a:r>
              <a:rPr lang="en-US" altLang="zh-HK" sz="1400" dirty="0"/>
              <a:t>-15.92 kcal/</a:t>
            </a:r>
            <a:r>
              <a:rPr lang="en-US" altLang="zh-HK" sz="1400" dirty="0" err="1"/>
              <a:t>mol</a:t>
            </a:r>
            <a:endParaRPr lang="zh-HK" altLang="en-US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661000" y="661506"/>
            <a:ext cx="17722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400" dirty="0"/>
              <a:t>GAPDH</a:t>
            </a:r>
          </a:p>
          <a:p>
            <a:r>
              <a:rPr lang="en-US" altLang="zh-HK" sz="1400" dirty="0"/>
              <a:t>-42.32 kcal/</a:t>
            </a:r>
            <a:r>
              <a:rPr lang="en-US" altLang="zh-HK" sz="1400" dirty="0" err="1"/>
              <a:t>mol</a:t>
            </a:r>
            <a:endParaRPr lang="zh-HK" altLang="en-US" sz="1400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961754">
            <a:off x="249712" y="4003460"/>
            <a:ext cx="2770847" cy="2348984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6557323">
            <a:off x="3011036" y="1454563"/>
            <a:ext cx="1219770" cy="121977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682283" y="3306638"/>
            <a:ext cx="18924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400" dirty="0"/>
              <a:t>ER</a:t>
            </a:r>
            <a:r>
              <a:rPr lang="el-GR" altLang="zh-HK" sz="1400" dirty="0">
                <a:latin typeface="Minion Pro Med" panose="02040503050201020203" pitchFamily="18" charset="0"/>
              </a:rPr>
              <a:t>α</a:t>
            </a:r>
            <a:endParaRPr lang="en-US" altLang="zh-HK" sz="1400" dirty="0">
              <a:latin typeface="Minion Pro Med" panose="02040503050201020203" pitchFamily="18" charset="0"/>
            </a:endParaRPr>
          </a:p>
          <a:p>
            <a:r>
              <a:rPr lang="en-US" altLang="zh-HK" sz="1400" dirty="0"/>
              <a:t>-111.98 kcal/</a:t>
            </a:r>
            <a:r>
              <a:rPr lang="en-US" altLang="zh-HK" sz="1400" dirty="0" err="1"/>
              <a:t>mol</a:t>
            </a:r>
            <a:endParaRPr lang="zh-HK" alt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2934432" y="3181786"/>
            <a:ext cx="18535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400" dirty="0"/>
              <a:t>FOXM1</a:t>
            </a:r>
            <a:endParaRPr lang="en-US" altLang="zh-HK" sz="1400" dirty="0">
              <a:latin typeface="Minion Pro Med" panose="02040503050201020203" pitchFamily="18" charset="0"/>
            </a:endParaRPr>
          </a:p>
          <a:p>
            <a:r>
              <a:rPr lang="en-US" altLang="zh-HK" sz="1400" dirty="0"/>
              <a:t>-128.78 kcal/</a:t>
            </a:r>
            <a:r>
              <a:rPr lang="en-US" altLang="zh-HK" sz="1400" dirty="0" err="1"/>
              <a:t>mol</a:t>
            </a:r>
            <a:endParaRPr lang="zh-HK" altLang="en-US" sz="1400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279074">
            <a:off x="2912905" y="3909524"/>
            <a:ext cx="2641356" cy="264135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00998" y="44548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a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2433246" y="43764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b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4401055" y="41250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c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6444208" y="40466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d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211596" y="295647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e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2443844" y="2948630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f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05</TotalTime>
  <Words>44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Minion Pro Med</vt:lpstr>
      <vt:lpstr>新細明體</vt:lpstr>
      <vt:lpstr>Office Theme</vt:lpstr>
      <vt:lpstr>PowerPoint Presentation</vt:lpstr>
    </vt:vector>
  </TitlesOfParts>
  <Company>The University of Hong Ko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Tsoi Ho</dc:creator>
  <cp:lastModifiedBy>Windows User</cp:lastModifiedBy>
  <cp:revision>98</cp:revision>
  <cp:lastPrinted>2019-05-24T08:26:42Z</cp:lastPrinted>
  <dcterms:created xsi:type="dcterms:W3CDTF">2017-10-03T01:31:32Z</dcterms:created>
  <dcterms:modified xsi:type="dcterms:W3CDTF">2020-01-29T02:57:55Z</dcterms:modified>
</cp:coreProperties>
</file>